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C26356-DBD8-48E0-AEFD-34718852B3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A558ED-D5F9-44AE-97F4-9AD14D78A7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161B6C-3346-4C7A-AEE8-B48C96D085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FE5E43-EE03-4E24-B5B9-2E9C066D3DE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361910-9D42-47FF-B0F7-BB91D218C6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6E34A5-C357-4185-8CC6-75949B753F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6A16C8-D639-4268-9FFB-DE4FA4CBD5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34AD5-E76A-4CD0-B00B-ECB8043342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7E451A-8FAF-482C-8F1B-919B6413AD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F05689-DE61-447D-B476-82C214A897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343246-82FF-4E8D-B0FB-D2338C7372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BF7ED4-8673-497C-92FA-91397135D7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CC8458-F5EC-4A44-A857-DD3E2A54273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3075120" y="1158840"/>
            <a:ext cx="2009520" cy="152388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3284640" y="1336680"/>
            <a:ext cx="21564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2"/>
          <a:stretch/>
        </p:blipFill>
        <p:spPr>
          <a:xfrm>
            <a:off x="1790640" y="1303200"/>
            <a:ext cx="3943440" cy="240984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1268280" y="5168880"/>
            <a:ext cx="4321440" cy="83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300" spc="-1" strike="noStrike">
                <a:solidFill>
                  <a:srgbClr val="000000"/>
                </a:solidFill>
                <a:latin typeface="Times New Roman"/>
              </a:rPr>
              <a:t>Supplementary Data 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Frequency histogram of ATC Unigene lengths for all (black), contig (grey) and singleton (white) sequences. Exploded view of sequences between 3000bp and 7000bp inset in top right of char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30T11:14:27Z</dcterms:created>
  <dc:creator>Kieron Edwards</dc:creator>
  <dc:description/>
  <dc:language>en-US</dc:language>
  <cp:lastModifiedBy>edwardki</cp:lastModifiedBy>
  <dcterms:modified xsi:type="dcterms:W3CDTF">2009-09-28T10:35:23Z</dcterms:modified>
  <cp:revision>8</cp:revision>
  <dc:subject/>
  <dc:title>Slide 1</dc:title>
</cp:coreProperties>
</file>